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2D261-5609-49C4-9914-D8AD41B92B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C2AFC-BFCA-4D7B-86A7-8B8A64E3C6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52FE9-DE25-45A2-807A-A40712B7E1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CD6AB-4E0A-4896-A02E-596F8222FA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2C4D4-1EB9-4667-854E-A125DA447D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A600F-22B8-4619-A2EC-8781E9F377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A5FDB-30C0-4527-80A4-5CD2DEA1A0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5988F-F28D-4CCB-85A4-E055D8C1C2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D965D-5C74-4900-93C5-6D410BFF4B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86D54-E81C-4963-9B30-17DCAA47B3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AC2991-9D2E-47EB-8959-DB6A204C51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1294C-FE77-4085-91D0-EA6333FB45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3ADED5-2D2C-4E33-B90A-C720113F630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Freeform 330"/>
          <p:cNvSpPr/>
          <p:nvPr/>
        </p:nvSpPr>
        <p:spPr>
          <a:xfrm>
            <a:off x="6226200" y="4673520"/>
            <a:ext cx="1493640" cy="1613160"/>
          </a:xfrm>
          <a:custGeom>
            <a:avLst/>
            <a:gdLst>
              <a:gd name="textAreaLeft" fmla="*/ 0 w 1493640"/>
              <a:gd name="textAreaRight" fmla="*/ 1494000 w 1493640"/>
              <a:gd name="textAreaTop" fmla="*/ 0 h 1613160"/>
              <a:gd name="textAreaBottom" fmla="*/ 1613520 h 1613160"/>
            </a:gdLst>
            <a:ahLst/>
            <a:rect l="textAreaLeft" t="textAreaTop" r="textAreaRight" b="textAreaBottom"/>
            <a:pathLst>
              <a:path w="1035" h="1086">
                <a:moveTo>
                  <a:pt x="0" y="0"/>
                </a:moveTo>
                <a:lnTo>
                  <a:pt x="99" y="0"/>
                </a:lnTo>
                <a:lnTo>
                  <a:pt x="99" y="126"/>
                </a:lnTo>
                <a:lnTo>
                  <a:pt x="177" y="126"/>
                </a:lnTo>
                <a:lnTo>
                  <a:pt x="177" y="261"/>
                </a:lnTo>
                <a:lnTo>
                  <a:pt x="597" y="261"/>
                </a:lnTo>
                <a:lnTo>
                  <a:pt x="597" y="471"/>
                </a:lnTo>
                <a:lnTo>
                  <a:pt x="1035" y="471"/>
                </a:lnTo>
                <a:lnTo>
                  <a:pt x="1035" y="1086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57"/>
          <p:cNvSpPr/>
          <p:nvPr/>
        </p:nvSpPr>
        <p:spPr>
          <a:xfrm>
            <a:off x="3293280" y="6534000"/>
            <a:ext cx="139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Years after surg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58"/>
          <p:cNvSpPr/>
          <p:nvPr/>
        </p:nvSpPr>
        <p:spPr>
          <a:xfrm>
            <a:off x="5104440" y="634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59"/>
          <p:cNvSpPr/>
          <p:nvPr/>
        </p:nvSpPr>
        <p:spPr>
          <a:xfrm>
            <a:off x="4715640" y="634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60"/>
          <p:cNvSpPr/>
          <p:nvPr/>
        </p:nvSpPr>
        <p:spPr>
          <a:xfrm>
            <a:off x="4325040" y="634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61"/>
          <p:cNvSpPr/>
          <p:nvPr/>
        </p:nvSpPr>
        <p:spPr>
          <a:xfrm>
            <a:off x="3937680" y="634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62"/>
          <p:cNvSpPr/>
          <p:nvPr/>
        </p:nvSpPr>
        <p:spPr>
          <a:xfrm>
            <a:off x="3552120" y="634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63"/>
          <p:cNvSpPr/>
          <p:nvPr/>
        </p:nvSpPr>
        <p:spPr>
          <a:xfrm>
            <a:off x="3159720" y="6346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64"/>
          <p:cNvSpPr/>
          <p:nvPr/>
        </p:nvSpPr>
        <p:spPr>
          <a:xfrm>
            <a:off x="2704320" y="63374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65"/>
          <p:cNvSpPr/>
          <p:nvPr/>
        </p:nvSpPr>
        <p:spPr>
          <a:xfrm rot="16200000">
            <a:off x="1749600" y="5453280"/>
            <a:ext cx="146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verall survival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66"/>
          <p:cNvSpPr/>
          <p:nvPr/>
        </p:nvSpPr>
        <p:spPr>
          <a:xfrm>
            <a:off x="2533680" y="4646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67"/>
          <p:cNvSpPr/>
          <p:nvPr/>
        </p:nvSpPr>
        <p:spPr>
          <a:xfrm>
            <a:off x="2629800" y="495936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68"/>
          <p:cNvSpPr/>
          <p:nvPr/>
        </p:nvSpPr>
        <p:spPr>
          <a:xfrm>
            <a:off x="2629800" y="527364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69"/>
          <p:cNvSpPr/>
          <p:nvPr/>
        </p:nvSpPr>
        <p:spPr>
          <a:xfrm>
            <a:off x="2631240" y="559116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70"/>
          <p:cNvSpPr/>
          <p:nvPr/>
        </p:nvSpPr>
        <p:spPr>
          <a:xfrm>
            <a:off x="2635920" y="590400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171"/>
          <p:cNvSpPr/>
          <p:nvPr/>
        </p:nvSpPr>
        <p:spPr>
          <a:xfrm>
            <a:off x="2798640" y="6313320"/>
            <a:ext cx="2330640" cy="11160"/>
          </a:xfrm>
          <a:custGeom>
            <a:avLst/>
            <a:gdLst>
              <a:gd name="textAreaLeft" fmla="*/ 0 w 2330640"/>
              <a:gd name="textAreaRight" fmla="*/ 2331000 w 233064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2208" h="12">
                <a:moveTo>
                  <a:pt x="2208" y="0"/>
                </a:moveTo>
                <a:lnTo>
                  <a:pt x="2208" y="12"/>
                </a:lnTo>
                <a:moveTo>
                  <a:pt x="1842" y="0"/>
                </a:moveTo>
                <a:lnTo>
                  <a:pt x="1842" y="12"/>
                </a:lnTo>
                <a:moveTo>
                  <a:pt x="1470" y="0"/>
                </a:moveTo>
                <a:lnTo>
                  <a:pt x="1470" y="12"/>
                </a:lnTo>
                <a:moveTo>
                  <a:pt x="1104" y="0"/>
                </a:moveTo>
                <a:lnTo>
                  <a:pt x="1104" y="12"/>
                </a:lnTo>
                <a:moveTo>
                  <a:pt x="738" y="0"/>
                </a:moveTo>
                <a:lnTo>
                  <a:pt x="738" y="12"/>
                </a:lnTo>
                <a:moveTo>
                  <a:pt x="366" y="0"/>
                </a:moveTo>
                <a:lnTo>
                  <a:pt x="366" y="12"/>
                </a:lnTo>
                <a:moveTo>
                  <a:pt x="0" y="0"/>
                </a:moveTo>
                <a:lnTo>
                  <a:pt x="0" y="1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172"/>
          <p:cNvSpPr/>
          <p:nvPr/>
        </p:nvSpPr>
        <p:spPr>
          <a:xfrm>
            <a:off x="2768760" y="4719600"/>
            <a:ext cx="17280" cy="1579680"/>
          </a:xfrm>
          <a:custGeom>
            <a:avLst/>
            <a:gdLst>
              <a:gd name="textAreaLeft" fmla="*/ 0 w 17280"/>
              <a:gd name="textAreaRight" fmla="*/ 17640 w 17280"/>
              <a:gd name="textAreaTop" fmla="*/ 0 h 1579680"/>
              <a:gd name="textAreaBottom" fmla="*/ 1580040 h 1579680"/>
            </a:gdLst>
            <a:ahLst/>
            <a:rect l="textAreaLeft" t="textAreaTop" r="textAreaRight" b="textAreaBottom"/>
            <a:pathLst>
              <a:path w="18" h="1776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8"/>
                </a:moveTo>
                <a:lnTo>
                  <a:pt x="18" y="708"/>
                </a:lnTo>
                <a:moveTo>
                  <a:pt x="0" y="1068"/>
                </a:moveTo>
                <a:lnTo>
                  <a:pt x="18" y="1068"/>
                </a:lnTo>
                <a:moveTo>
                  <a:pt x="0" y="1422"/>
                </a:moveTo>
                <a:lnTo>
                  <a:pt x="18" y="1422"/>
                </a:lnTo>
                <a:moveTo>
                  <a:pt x="0" y="1776"/>
                </a:moveTo>
                <a:lnTo>
                  <a:pt x="18" y="1776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74"/>
          <p:cNvSpPr/>
          <p:nvPr/>
        </p:nvSpPr>
        <p:spPr>
          <a:xfrm>
            <a:off x="2798640" y="6308640"/>
            <a:ext cx="2330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75"/>
          <p:cNvSpPr/>
          <p:nvPr/>
        </p:nvSpPr>
        <p:spPr>
          <a:xfrm flipV="1">
            <a:off x="2786040" y="4719600"/>
            <a:ext cx="0" cy="1579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606"/>
          <p:cNvSpPr/>
          <p:nvPr/>
        </p:nvSpPr>
        <p:spPr>
          <a:xfrm>
            <a:off x="2782800" y="4449600"/>
            <a:ext cx="256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+) or Ki67 (-) (n=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604"/>
          <p:cNvSpPr/>
          <p:nvPr/>
        </p:nvSpPr>
        <p:spPr>
          <a:xfrm>
            <a:off x="2890800" y="5202360"/>
            <a:ext cx="1495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-) a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i67 (+) (n=1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608"/>
          <p:cNvSpPr/>
          <p:nvPr/>
        </p:nvSpPr>
        <p:spPr>
          <a:xfrm>
            <a:off x="3588840" y="4836960"/>
            <a:ext cx="83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=0.03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263"/>
          <p:cNvSpPr/>
          <p:nvPr/>
        </p:nvSpPr>
        <p:spPr>
          <a:xfrm>
            <a:off x="2787480" y="4702320"/>
            <a:ext cx="2332080" cy="34920"/>
          </a:xfrm>
          <a:custGeom>
            <a:avLst/>
            <a:gdLst>
              <a:gd name="textAreaLeft" fmla="*/ 0 w 2332080"/>
              <a:gd name="textAreaRight" fmla="*/ 2332440 w 233208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528" h="1">
                <a:moveTo>
                  <a:pt x="0" y="0"/>
                </a:moveTo>
                <a:lnTo>
                  <a:pt x="1528" y="0"/>
                </a:lnTo>
                <a:lnTo>
                  <a:pt x="1504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264"/>
          <p:cNvSpPr/>
          <p:nvPr/>
        </p:nvSpPr>
        <p:spPr>
          <a:xfrm>
            <a:off x="2797200" y="4724280"/>
            <a:ext cx="2146320" cy="1567080"/>
          </a:xfrm>
          <a:custGeom>
            <a:avLst/>
            <a:gdLst>
              <a:gd name="textAreaLeft" fmla="*/ 0 w 2146320"/>
              <a:gd name="textAreaRight" fmla="*/ 2146320 w 2146320"/>
              <a:gd name="textAreaTop" fmla="*/ 0 h 1567080"/>
              <a:gd name="textAreaBottom" fmla="*/ 1567440 h 1567080"/>
            </a:gdLst>
            <a:ahLst/>
            <a:rect l="textAreaLeft" t="textAreaTop" r="textAreaRight" b="textAreaBottom"/>
            <a:pathLst>
              <a:path w="1376" h="1212">
                <a:moveTo>
                  <a:pt x="0" y="0"/>
                </a:moveTo>
                <a:lnTo>
                  <a:pt x="152" y="0"/>
                </a:lnTo>
                <a:lnTo>
                  <a:pt x="152" y="120"/>
                </a:lnTo>
                <a:lnTo>
                  <a:pt x="376" y="120"/>
                </a:lnTo>
                <a:lnTo>
                  <a:pt x="376" y="240"/>
                </a:lnTo>
                <a:lnTo>
                  <a:pt x="484" y="240"/>
                </a:lnTo>
                <a:lnTo>
                  <a:pt x="484" y="384"/>
                </a:lnTo>
                <a:lnTo>
                  <a:pt x="960" y="384"/>
                </a:lnTo>
                <a:lnTo>
                  <a:pt x="960" y="592"/>
                </a:lnTo>
                <a:lnTo>
                  <a:pt x="1096" y="592"/>
                </a:lnTo>
                <a:lnTo>
                  <a:pt x="1096" y="812"/>
                </a:lnTo>
                <a:lnTo>
                  <a:pt x="1376" y="812"/>
                </a:lnTo>
                <a:lnTo>
                  <a:pt x="1376" y="1212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"/>
          <p:cNvSpPr/>
          <p:nvPr/>
        </p:nvSpPr>
        <p:spPr>
          <a:xfrm>
            <a:off x="2653200" y="130320"/>
            <a:ext cx="4431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3. Kashiwagi S. et al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604"/>
          <p:cNvSpPr/>
          <p:nvPr/>
        </p:nvSpPr>
        <p:spPr>
          <a:xfrm>
            <a:off x="2793960" y="2448000"/>
            <a:ext cx="264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-) and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i67 (+) (n=1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正方形/長方形 608"/>
          <p:cNvSpPr/>
          <p:nvPr/>
        </p:nvSpPr>
        <p:spPr>
          <a:xfrm>
            <a:off x="3817440" y="2000160"/>
            <a:ext cx="83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=0.00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正方形/長方形 606"/>
          <p:cNvSpPr/>
          <p:nvPr/>
        </p:nvSpPr>
        <p:spPr>
          <a:xfrm>
            <a:off x="2760840" y="1633680"/>
            <a:ext cx="260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+) or Ki67 (-) (n=2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92"/>
          <p:cNvSpPr/>
          <p:nvPr/>
        </p:nvSpPr>
        <p:spPr>
          <a:xfrm>
            <a:off x="3141000" y="3759120"/>
            <a:ext cx="139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Years after surg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93"/>
          <p:cNvSpPr/>
          <p:nvPr/>
        </p:nvSpPr>
        <p:spPr>
          <a:xfrm>
            <a:off x="487584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94"/>
          <p:cNvSpPr/>
          <p:nvPr/>
        </p:nvSpPr>
        <p:spPr>
          <a:xfrm>
            <a:off x="449964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95"/>
          <p:cNvSpPr/>
          <p:nvPr/>
        </p:nvSpPr>
        <p:spPr>
          <a:xfrm>
            <a:off x="414252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96"/>
          <p:cNvSpPr/>
          <p:nvPr/>
        </p:nvSpPr>
        <p:spPr>
          <a:xfrm>
            <a:off x="378216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97"/>
          <p:cNvSpPr/>
          <p:nvPr/>
        </p:nvSpPr>
        <p:spPr>
          <a:xfrm>
            <a:off x="342036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98"/>
          <p:cNvSpPr/>
          <p:nvPr/>
        </p:nvSpPr>
        <p:spPr>
          <a:xfrm>
            <a:off x="305028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99"/>
          <p:cNvSpPr/>
          <p:nvPr/>
        </p:nvSpPr>
        <p:spPr>
          <a:xfrm>
            <a:off x="2626560" y="36082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200"/>
          <p:cNvSpPr/>
          <p:nvPr/>
        </p:nvSpPr>
        <p:spPr>
          <a:xfrm rot="16200000">
            <a:off x="1730520" y="2683800"/>
            <a:ext cx="146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verall survival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01"/>
          <p:cNvSpPr/>
          <p:nvPr/>
        </p:nvSpPr>
        <p:spPr>
          <a:xfrm>
            <a:off x="2506680" y="18525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02"/>
          <p:cNvSpPr/>
          <p:nvPr/>
        </p:nvSpPr>
        <p:spPr>
          <a:xfrm>
            <a:off x="2581920" y="21826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203"/>
          <p:cNvSpPr/>
          <p:nvPr/>
        </p:nvSpPr>
        <p:spPr>
          <a:xfrm>
            <a:off x="2581920" y="25066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204"/>
          <p:cNvSpPr/>
          <p:nvPr/>
        </p:nvSpPr>
        <p:spPr>
          <a:xfrm>
            <a:off x="2586960" y="284004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205"/>
          <p:cNvSpPr/>
          <p:nvPr/>
        </p:nvSpPr>
        <p:spPr>
          <a:xfrm>
            <a:off x="2581920" y="317340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215"/>
          <p:cNvSpPr/>
          <p:nvPr/>
        </p:nvSpPr>
        <p:spPr>
          <a:xfrm>
            <a:off x="2732040" y="3573360"/>
            <a:ext cx="2168640" cy="9720"/>
          </a:xfrm>
          <a:custGeom>
            <a:avLst/>
            <a:gdLst>
              <a:gd name="textAreaLeft" fmla="*/ 0 w 2168640"/>
              <a:gd name="textAreaRight" fmla="*/ 2169000 w 216864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1460" h="8">
                <a:moveTo>
                  <a:pt x="1460" y="0"/>
                </a:moveTo>
                <a:lnTo>
                  <a:pt x="1460" y="8"/>
                </a:lnTo>
                <a:moveTo>
                  <a:pt x="1217" y="0"/>
                </a:moveTo>
                <a:lnTo>
                  <a:pt x="1217" y="8"/>
                </a:lnTo>
                <a:moveTo>
                  <a:pt x="974" y="0"/>
                </a:moveTo>
                <a:lnTo>
                  <a:pt x="974" y="8"/>
                </a:lnTo>
                <a:moveTo>
                  <a:pt x="730" y="0"/>
                </a:moveTo>
                <a:lnTo>
                  <a:pt x="730" y="8"/>
                </a:lnTo>
                <a:moveTo>
                  <a:pt x="487" y="0"/>
                </a:moveTo>
                <a:lnTo>
                  <a:pt x="487" y="8"/>
                </a:lnTo>
                <a:moveTo>
                  <a:pt x="244" y="0"/>
                </a:moveTo>
                <a:lnTo>
                  <a:pt x="244" y="8"/>
                </a:lnTo>
                <a:moveTo>
                  <a:pt x="0" y="0"/>
                </a:moveTo>
                <a:lnTo>
                  <a:pt x="0" y="8"/>
                </a:lnTo>
              </a:path>
            </a:pathLst>
          </a:cu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216"/>
          <p:cNvSpPr/>
          <p:nvPr/>
        </p:nvSpPr>
        <p:spPr>
          <a:xfrm>
            <a:off x="2714760" y="1928880"/>
            <a:ext cx="17280" cy="1638360"/>
          </a:xfrm>
          <a:custGeom>
            <a:avLst/>
            <a:gdLst>
              <a:gd name="textAreaLeft" fmla="*/ 0 w 17280"/>
              <a:gd name="textAreaRight" fmla="*/ 17640 w 17280"/>
              <a:gd name="textAreaTop" fmla="*/ 0 h 1638360"/>
              <a:gd name="textAreaBottom" fmla="*/ 1638720 h 1638360"/>
            </a:gdLst>
            <a:ahLst/>
            <a:rect l="textAreaLeft" t="textAreaTop" r="textAreaRight" b="textAreaBottom"/>
            <a:pathLst>
              <a:path w="12" h="1241">
                <a:moveTo>
                  <a:pt x="0" y="0"/>
                </a:moveTo>
                <a:lnTo>
                  <a:pt x="12" y="0"/>
                </a:lnTo>
                <a:moveTo>
                  <a:pt x="0" y="247"/>
                </a:moveTo>
                <a:lnTo>
                  <a:pt x="12" y="247"/>
                </a:lnTo>
                <a:moveTo>
                  <a:pt x="0" y="494"/>
                </a:moveTo>
                <a:lnTo>
                  <a:pt x="12" y="494"/>
                </a:lnTo>
                <a:moveTo>
                  <a:pt x="0" y="746"/>
                </a:moveTo>
                <a:lnTo>
                  <a:pt x="12" y="746"/>
                </a:lnTo>
                <a:moveTo>
                  <a:pt x="0" y="993"/>
                </a:moveTo>
                <a:lnTo>
                  <a:pt x="12" y="993"/>
                </a:lnTo>
                <a:moveTo>
                  <a:pt x="0" y="1241"/>
                </a:moveTo>
                <a:lnTo>
                  <a:pt x="12" y="1241"/>
                </a:lnTo>
              </a:path>
            </a:pathLst>
          </a:cu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219"/>
          <p:cNvSpPr/>
          <p:nvPr/>
        </p:nvSpPr>
        <p:spPr>
          <a:xfrm>
            <a:off x="2732040" y="3567240"/>
            <a:ext cx="2168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220"/>
          <p:cNvSpPr/>
          <p:nvPr/>
        </p:nvSpPr>
        <p:spPr>
          <a:xfrm flipV="1">
            <a:off x="2732040" y="1928520"/>
            <a:ext cx="0" cy="1638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258"/>
          <p:cNvSpPr/>
          <p:nvPr/>
        </p:nvSpPr>
        <p:spPr>
          <a:xfrm>
            <a:off x="2730600" y="1928880"/>
            <a:ext cx="2170080" cy="496800"/>
          </a:xfrm>
          <a:custGeom>
            <a:avLst/>
            <a:gdLst>
              <a:gd name="textAreaLeft" fmla="*/ 0 w 2170080"/>
              <a:gd name="textAreaRight" fmla="*/ 2170440 w 2170080"/>
              <a:gd name="textAreaTop" fmla="*/ 0 h 496800"/>
              <a:gd name="textAreaBottom" fmla="*/ 497160 h 496800"/>
            </a:gdLst>
            <a:ahLst/>
            <a:rect l="textAreaLeft" t="textAreaTop" r="textAreaRight" b="textAreaBottom"/>
            <a:pathLst>
              <a:path w="1461" h="375">
                <a:moveTo>
                  <a:pt x="0" y="0"/>
                </a:moveTo>
                <a:lnTo>
                  <a:pt x="261" y="0"/>
                </a:lnTo>
                <a:lnTo>
                  <a:pt x="261" y="114"/>
                </a:lnTo>
                <a:lnTo>
                  <a:pt x="405" y="114"/>
                </a:lnTo>
                <a:lnTo>
                  <a:pt x="405" y="228"/>
                </a:lnTo>
                <a:lnTo>
                  <a:pt x="687" y="228"/>
                </a:lnTo>
                <a:lnTo>
                  <a:pt x="687" y="375"/>
                </a:lnTo>
                <a:lnTo>
                  <a:pt x="1461" y="375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6"/>
          <p:cNvSpPr/>
          <p:nvPr/>
        </p:nvSpPr>
        <p:spPr>
          <a:xfrm>
            <a:off x="2434320" y="1187280"/>
            <a:ext cx="345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rger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+ adjuvant therapy (n=38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21"/>
          <p:cNvSpPr/>
          <p:nvPr/>
        </p:nvSpPr>
        <p:spPr>
          <a:xfrm>
            <a:off x="6031080" y="1171440"/>
            <a:ext cx="266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rgery alone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n=2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71"/>
          <p:cNvSpPr/>
          <p:nvPr/>
        </p:nvSpPr>
        <p:spPr>
          <a:xfrm>
            <a:off x="552600" y="1174680"/>
            <a:ext cx="1963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age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(n=59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73"/>
          <p:cNvSpPr/>
          <p:nvPr/>
        </p:nvSpPr>
        <p:spPr>
          <a:xfrm>
            <a:off x="560520" y="4017960"/>
            <a:ext cx="208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age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III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(n=2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2"/>
          <p:cNvSpPr/>
          <p:nvPr/>
        </p:nvSpPr>
        <p:spPr>
          <a:xfrm>
            <a:off x="6600240" y="3710160"/>
            <a:ext cx="139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9"/>
          <p:cNvSpPr/>
          <p:nvPr/>
        </p:nvSpPr>
        <p:spPr>
          <a:xfrm rot="16200000">
            <a:off x="5181840" y="2637000"/>
            <a:ext cx="146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20"/>
          <p:cNvSpPr/>
          <p:nvPr/>
        </p:nvSpPr>
        <p:spPr>
          <a:xfrm>
            <a:off x="5962680" y="1778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21"/>
          <p:cNvSpPr/>
          <p:nvPr/>
        </p:nvSpPr>
        <p:spPr>
          <a:xfrm>
            <a:off x="6028560" y="21016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22"/>
          <p:cNvSpPr/>
          <p:nvPr/>
        </p:nvSpPr>
        <p:spPr>
          <a:xfrm>
            <a:off x="6028560" y="246852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23"/>
          <p:cNvSpPr/>
          <p:nvPr/>
        </p:nvSpPr>
        <p:spPr>
          <a:xfrm>
            <a:off x="6028560" y="279072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24"/>
          <p:cNvSpPr/>
          <p:nvPr/>
        </p:nvSpPr>
        <p:spPr>
          <a:xfrm>
            <a:off x="6028560" y="313056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36"/>
          <p:cNvSpPr/>
          <p:nvPr/>
        </p:nvSpPr>
        <p:spPr>
          <a:xfrm>
            <a:off x="6181560" y="1859040"/>
            <a:ext cx="19080" cy="1677960"/>
          </a:xfrm>
          <a:custGeom>
            <a:avLst/>
            <a:gdLst>
              <a:gd name="textAreaLeft" fmla="*/ 0 w 19080"/>
              <a:gd name="textAreaRight" fmla="*/ 19440 w 19080"/>
              <a:gd name="textAreaTop" fmla="*/ 0 h 1677960"/>
              <a:gd name="textAreaBottom" fmla="*/ 1678320 h 1677960"/>
            </a:gdLst>
            <a:ahLst/>
            <a:rect l="textAreaLeft" t="textAreaTop" r="textAreaRight" b="textAreaBottom"/>
            <a:pathLst>
              <a:path w="18" h="1778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9"/>
                </a:moveTo>
                <a:lnTo>
                  <a:pt x="18" y="709"/>
                </a:lnTo>
                <a:moveTo>
                  <a:pt x="0" y="1069"/>
                </a:moveTo>
                <a:lnTo>
                  <a:pt x="18" y="1069"/>
                </a:lnTo>
                <a:moveTo>
                  <a:pt x="0" y="1423"/>
                </a:moveTo>
                <a:lnTo>
                  <a:pt x="18" y="1423"/>
                </a:lnTo>
                <a:moveTo>
                  <a:pt x="0" y="1778"/>
                </a:moveTo>
                <a:lnTo>
                  <a:pt x="18" y="1778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37"/>
          <p:cNvSpPr/>
          <p:nvPr/>
        </p:nvSpPr>
        <p:spPr>
          <a:xfrm>
            <a:off x="6249960" y="1878120"/>
            <a:ext cx="2203560" cy="561960"/>
          </a:xfrm>
          <a:custGeom>
            <a:avLst/>
            <a:gdLst>
              <a:gd name="textAreaLeft" fmla="*/ 0 w 2203560"/>
              <a:gd name="textAreaRight" fmla="*/ 2203920 w 2203560"/>
              <a:gd name="textAreaTop" fmla="*/ 0 h 561960"/>
              <a:gd name="textAreaBottom" fmla="*/ 562320 h 561960"/>
            </a:gdLst>
            <a:ahLst/>
            <a:rect l="textAreaLeft" t="textAreaTop" r="textAreaRight" b="textAreaBottom"/>
            <a:pathLst>
              <a:path w="1932" h="595">
                <a:moveTo>
                  <a:pt x="462" y="595"/>
                </a:moveTo>
                <a:lnTo>
                  <a:pt x="1932" y="595"/>
                </a:lnTo>
                <a:moveTo>
                  <a:pt x="462" y="0"/>
                </a:moveTo>
                <a:lnTo>
                  <a:pt x="462" y="595"/>
                </a:lnTo>
                <a:moveTo>
                  <a:pt x="0" y="0"/>
                </a:moveTo>
                <a:lnTo>
                  <a:pt x="462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42"/>
          <p:cNvSpPr/>
          <p:nvPr/>
        </p:nvSpPr>
        <p:spPr>
          <a:xfrm flipV="1">
            <a:off x="6200640" y="1858680"/>
            <a:ext cx="1800" cy="1677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グループ化 90"/>
          <p:cNvGrpSpPr/>
          <p:nvPr/>
        </p:nvGrpSpPr>
        <p:grpSpPr>
          <a:xfrm>
            <a:off x="6094800" y="3525840"/>
            <a:ext cx="2350080" cy="214920"/>
            <a:chOff x="6094800" y="3525840"/>
            <a:chExt cx="2350080" cy="214920"/>
          </a:xfrm>
        </p:grpSpPr>
        <p:sp>
          <p:nvSpPr>
            <p:cNvPr id="103" name="Rectangle 51"/>
            <p:cNvSpPr/>
            <p:nvPr/>
          </p:nvSpPr>
          <p:spPr>
            <a:xfrm>
              <a:off x="835884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52"/>
            <p:cNvSpPr/>
            <p:nvPr/>
          </p:nvSpPr>
          <p:spPr>
            <a:xfrm>
              <a:off x="799056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53"/>
            <p:cNvSpPr/>
            <p:nvPr/>
          </p:nvSpPr>
          <p:spPr>
            <a:xfrm>
              <a:off x="762696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54"/>
            <p:cNvSpPr/>
            <p:nvPr/>
          </p:nvSpPr>
          <p:spPr>
            <a:xfrm>
              <a:off x="725832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55"/>
            <p:cNvSpPr/>
            <p:nvPr/>
          </p:nvSpPr>
          <p:spPr>
            <a:xfrm>
              <a:off x="688860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56"/>
            <p:cNvSpPr/>
            <p:nvPr/>
          </p:nvSpPr>
          <p:spPr>
            <a:xfrm>
              <a:off x="652644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57"/>
            <p:cNvSpPr/>
            <p:nvPr/>
          </p:nvSpPr>
          <p:spPr>
            <a:xfrm>
              <a:off x="6094800" y="3557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4"/>
            <p:cNvSpPr/>
            <p:nvPr/>
          </p:nvSpPr>
          <p:spPr>
            <a:xfrm>
              <a:off x="6184440" y="3530160"/>
              <a:ext cx="2202120" cy="9000"/>
            </a:xfrm>
            <a:custGeom>
              <a:avLst/>
              <a:gdLst>
                <a:gd name="textAreaLeft" fmla="*/ 0 w 2202120"/>
                <a:gd name="textAreaRight" fmla="*/ 2202480 w 2202120"/>
                <a:gd name="textAreaTop" fmla="*/ 0 h 9000"/>
                <a:gd name="textAreaBottom" fmla="*/ 9360 h 9000"/>
              </a:gdLst>
              <a:ahLst/>
              <a:rect l="textAreaLeft" t="textAreaTop" r="textAreaRight" b="textAreaBottom"/>
              <a:pathLst>
                <a:path w="1968" h="12">
                  <a:moveTo>
                    <a:pt x="1968" y="0"/>
                  </a:moveTo>
                  <a:lnTo>
                    <a:pt x="1968" y="12"/>
                  </a:lnTo>
                  <a:moveTo>
                    <a:pt x="1638" y="0"/>
                  </a:moveTo>
                  <a:lnTo>
                    <a:pt x="1638" y="12"/>
                  </a:lnTo>
                  <a:moveTo>
                    <a:pt x="1314" y="0"/>
                  </a:moveTo>
                  <a:lnTo>
                    <a:pt x="1314" y="12"/>
                  </a:lnTo>
                  <a:moveTo>
                    <a:pt x="984" y="0"/>
                  </a:moveTo>
                  <a:lnTo>
                    <a:pt x="984" y="12"/>
                  </a:lnTo>
                  <a:moveTo>
                    <a:pt x="654" y="0"/>
                  </a:moveTo>
                  <a:lnTo>
                    <a:pt x="654" y="12"/>
                  </a:lnTo>
                  <a:moveTo>
                    <a:pt x="330" y="0"/>
                  </a:moveTo>
                  <a:lnTo>
                    <a:pt x="330" y="12"/>
                  </a:lnTo>
                  <a:moveTo>
                    <a:pt x="0" y="0"/>
                  </a:moveTo>
                  <a:lnTo>
                    <a:pt x="0" y="12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80"/>
            <p:cNvSpPr/>
            <p:nvPr/>
          </p:nvSpPr>
          <p:spPr>
            <a:xfrm>
              <a:off x="6184440" y="3525840"/>
              <a:ext cx="2202120" cy="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2" name="テキスト ボックス 604"/>
          <p:cNvSpPr/>
          <p:nvPr/>
        </p:nvSpPr>
        <p:spPr>
          <a:xfrm>
            <a:off x="6386400" y="2565360"/>
            <a:ext cx="25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-) and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i67 (+) (n=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正方形/長方形 606"/>
          <p:cNvSpPr/>
          <p:nvPr/>
        </p:nvSpPr>
        <p:spPr>
          <a:xfrm>
            <a:off x="6249960" y="1617840"/>
            <a:ext cx="260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+) or Ki67 (-) (n=1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正方形/長方形 608"/>
          <p:cNvSpPr/>
          <p:nvPr/>
        </p:nvSpPr>
        <p:spPr>
          <a:xfrm>
            <a:off x="6787440" y="2050920"/>
            <a:ext cx="83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=0.7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301"/>
          <p:cNvSpPr/>
          <p:nvPr/>
        </p:nvSpPr>
        <p:spPr>
          <a:xfrm>
            <a:off x="6254640" y="1860480"/>
            <a:ext cx="2210040" cy="663480"/>
          </a:xfrm>
          <a:custGeom>
            <a:avLst/>
            <a:gdLst>
              <a:gd name="textAreaLeft" fmla="*/ 0 w 2210040"/>
              <a:gd name="textAreaRight" fmla="*/ 2210400 w 2210040"/>
              <a:gd name="textAreaTop" fmla="*/ 0 h 663480"/>
              <a:gd name="textAreaBottom" fmla="*/ 663840 h 663480"/>
            </a:gdLst>
            <a:ahLst/>
            <a:rect l="textAreaLeft" t="textAreaTop" r="textAreaRight" b="textAreaBottom"/>
            <a:pathLst>
              <a:path w="1530" h="447">
                <a:moveTo>
                  <a:pt x="0" y="0"/>
                </a:moveTo>
                <a:cubicBezTo>
                  <a:pt x="15" y="0"/>
                  <a:pt x="30" y="0"/>
                  <a:pt x="45" y="0"/>
                </a:cubicBezTo>
                <a:lnTo>
                  <a:pt x="945" y="0"/>
                </a:lnTo>
                <a:lnTo>
                  <a:pt x="945" y="228"/>
                </a:lnTo>
                <a:lnTo>
                  <a:pt x="1212" y="228"/>
                </a:lnTo>
                <a:lnTo>
                  <a:pt x="1212" y="447"/>
                </a:lnTo>
                <a:lnTo>
                  <a:pt x="1530" y="44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テキスト ボックス 6"/>
          <p:cNvSpPr/>
          <p:nvPr/>
        </p:nvSpPr>
        <p:spPr>
          <a:xfrm>
            <a:off x="2596320" y="4092480"/>
            <a:ext cx="345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rger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+ adjuvant therapy (n=1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テキスト ボックス 21"/>
          <p:cNvSpPr/>
          <p:nvPr/>
        </p:nvSpPr>
        <p:spPr>
          <a:xfrm>
            <a:off x="5924520" y="4067280"/>
            <a:ext cx="266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rgery alone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n=9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91"/>
          <p:cNvSpPr/>
          <p:nvPr/>
        </p:nvSpPr>
        <p:spPr>
          <a:xfrm>
            <a:off x="6639840" y="6523200"/>
            <a:ext cx="139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Years after surg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92"/>
          <p:cNvSpPr/>
          <p:nvPr/>
        </p:nvSpPr>
        <p:spPr>
          <a:xfrm>
            <a:off x="8352720" y="632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93"/>
          <p:cNvSpPr/>
          <p:nvPr/>
        </p:nvSpPr>
        <p:spPr>
          <a:xfrm>
            <a:off x="7994520" y="632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94"/>
          <p:cNvSpPr/>
          <p:nvPr/>
        </p:nvSpPr>
        <p:spPr>
          <a:xfrm>
            <a:off x="7630200" y="632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95"/>
          <p:cNvSpPr/>
          <p:nvPr/>
        </p:nvSpPr>
        <p:spPr>
          <a:xfrm>
            <a:off x="7272360" y="632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96"/>
          <p:cNvSpPr/>
          <p:nvPr/>
        </p:nvSpPr>
        <p:spPr>
          <a:xfrm>
            <a:off x="6912720" y="632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97"/>
          <p:cNvSpPr/>
          <p:nvPr/>
        </p:nvSpPr>
        <p:spPr>
          <a:xfrm>
            <a:off x="6549120" y="6327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98"/>
          <p:cNvSpPr/>
          <p:nvPr/>
        </p:nvSpPr>
        <p:spPr>
          <a:xfrm>
            <a:off x="6149160" y="6302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99"/>
          <p:cNvSpPr/>
          <p:nvPr/>
        </p:nvSpPr>
        <p:spPr>
          <a:xfrm rot="16200000">
            <a:off x="5221440" y="5442120"/>
            <a:ext cx="146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00"/>
          <p:cNvSpPr/>
          <p:nvPr/>
        </p:nvSpPr>
        <p:spPr>
          <a:xfrm>
            <a:off x="5999400" y="45896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01"/>
          <p:cNvSpPr/>
          <p:nvPr/>
        </p:nvSpPr>
        <p:spPr>
          <a:xfrm>
            <a:off x="6076080" y="490392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02"/>
          <p:cNvSpPr/>
          <p:nvPr/>
        </p:nvSpPr>
        <p:spPr>
          <a:xfrm>
            <a:off x="6076080" y="523224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03"/>
          <p:cNvSpPr/>
          <p:nvPr/>
        </p:nvSpPr>
        <p:spPr>
          <a:xfrm>
            <a:off x="6076080" y="55594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04"/>
          <p:cNvSpPr/>
          <p:nvPr/>
        </p:nvSpPr>
        <p:spPr>
          <a:xfrm>
            <a:off x="6076080" y="589104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112"/>
          <p:cNvSpPr/>
          <p:nvPr/>
        </p:nvSpPr>
        <p:spPr>
          <a:xfrm>
            <a:off x="6215040" y="6294600"/>
            <a:ext cx="2163960" cy="10800"/>
          </a:xfrm>
          <a:custGeom>
            <a:avLst/>
            <a:gdLst>
              <a:gd name="textAreaLeft" fmla="*/ 0 w 2163960"/>
              <a:gd name="textAreaRight" fmla="*/ 2164320 w 2163960"/>
              <a:gd name="textAreaTop" fmla="*/ 0 h 10800"/>
              <a:gd name="textAreaBottom" fmla="*/ 11160 h 10800"/>
            </a:gdLst>
            <a:ahLst/>
            <a:rect l="textAreaLeft" t="textAreaTop" r="textAreaRight" b="textAreaBottom"/>
            <a:pathLst>
              <a:path w="2208" h="12">
                <a:moveTo>
                  <a:pt x="2208" y="0"/>
                </a:moveTo>
                <a:lnTo>
                  <a:pt x="2208" y="12"/>
                </a:lnTo>
                <a:moveTo>
                  <a:pt x="1842" y="0"/>
                </a:moveTo>
                <a:lnTo>
                  <a:pt x="1842" y="12"/>
                </a:lnTo>
                <a:moveTo>
                  <a:pt x="1470" y="0"/>
                </a:moveTo>
                <a:lnTo>
                  <a:pt x="1470" y="12"/>
                </a:lnTo>
                <a:moveTo>
                  <a:pt x="1104" y="0"/>
                </a:moveTo>
                <a:lnTo>
                  <a:pt x="1104" y="12"/>
                </a:lnTo>
                <a:moveTo>
                  <a:pt x="738" y="0"/>
                </a:moveTo>
                <a:lnTo>
                  <a:pt x="738" y="12"/>
                </a:lnTo>
                <a:moveTo>
                  <a:pt x="366" y="0"/>
                </a:moveTo>
                <a:lnTo>
                  <a:pt x="366" y="12"/>
                </a:lnTo>
                <a:moveTo>
                  <a:pt x="0" y="0"/>
                </a:moveTo>
                <a:lnTo>
                  <a:pt x="0" y="12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113"/>
          <p:cNvSpPr/>
          <p:nvPr/>
        </p:nvSpPr>
        <p:spPr>
          <a:xfrm>
            <a:off x="6195960" y="4678200"/>
            <a:ext cx="19080" cy="1609920"/>
          </a:xfrm>
          <a:custGeom>
            <a:avLst/>
            <a:gdLst>
              <a:gd name="textAreaLeft" fmla="*/ 0 w 19080"/>
              <a:gd name="textAreaRight" fmla="*/ 19440 w 19080"/>
              <a:gd name="textAreaTop" fmla="*/ 0 h 1609920"/>
              <a:gd name="textAreaBottom" fmla="*/ 1610280 h 1609920"/>
            </a:gdLst>
            <a:ahLst/>
            <a:rect l="textAreaLeft" t="textAreaTop" r="textAreaRight" b="textAreaBottom"/>
            <a:pathLst>
              <a:path w="18" h="1778">
                <a:moveTo>
                  <a:pt x="0" y="0"/>
                </a:moveTo>
                <a:lnTo>
                  <a:pt x="18" y="0"/>
                </a:lnTo>
                <a:moveTo>
                  <a:pt x="0" y="354"/>
                </a:moveTo>
                <a:lnTo>
                  <a:pt x="18" y="354"/>
                </a:lnTo>
                <a:moveTo>
                  <a:pt x="0" y="709"/>
                </a:moveTo>
                <a:lnTo>
                  <a:pt x="18" y="709"/>
                </a:lnTo>
                <a:moveTo>
                  <a:pt x="0" y="1069"/>
                </a:moveTo>
                <a:lnTo>
                  <a:pt x="18" y="1069"/>
                </a:lnTo>
                <a:moveTo>
                  <a:pt x="0" y="1423"/>
                </a:moveTo>
                <a:lnTo>
                  <a:pt x="18" y="1423"/>
                </a:lnTo>
                <a:moveTo>
                  <a:pt x="0" y="1778"/>
                </a:moveTo>
                <a:lnTo>
                  <a:pt x="18" y="1778"/>
                </a:ln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16"/>
          <p:cNvSpPr/>
          <p:nvPr/>
        </p:nvSpPr>
        <p:spPr>
          <a:xfrm>
            <a:off x="6215040" y="6288120"/>
            <a:ext cx="2163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17"/>
          <p:cNvSpPr/>
          <p:nvPr/>
        </p:nvSpPr>
        <p:spPr>
          <a:xfrm flipV="1">
            <a:off x="6215040" y="4678200"/>
            <a:ext cx="0" cy="1609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正方形/長方形 606"/>
          <p:cNvSpPr/>
          <p:nvPr/>
        </p:nvSpPr>
        <p:spPr>
          <a:xfrm>
            <a:off x="6294600" y="4702320"/>
            <a:ext cx="258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 (+) or Ki67 (-) (n=9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333"/>
          <p:cNvSpPr/>
          <p:nvPr/>
        </p:nvSpPr>
        <p:spPr>
          <a:xfrm>
            <a:off x="2708280" y="1913040"/>
            <a:ext cx="2208240" cy="42840"/>
          </a:xfrm>
          <a:custGeom>
            <a:avLst/>
            <a:gdLst>
              <a:gd name="textAreaLeft" fmla="*/ 0 w 2208240"/>
              <a:gd name="textAreaRight" fmla="*/ 2208600 w 220824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1528" h="1">
                <a:moveTo>
                  <a:pt x="0" y="0"/>
                </a:moveTo>
                <a:lnTo>
                  <a:pt x="1528" y="0"/>
                </a:lnTo>
                <a:lnTo>
                  <a:pt x="1504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64"/>
          <p:cNvSpPr/>
          <p:nvPr/>
        </p:nvSpPr>
        <p:spPr>
          <a:xfrm>
            <a:off x="200160" y="1135080"/>
            <a:ext cx="43632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64"/>
          <p:cNvSpPr/>
          <p:nvPr/>
        </p:nvSpPr>
        <p:spPr>
          <a:xfrm>
            <a:off x="209520" y="3967200"/>
            <a:ext cx="39996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4400" y="636480"/>
            <a:ext cx="914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gnificance of E-cadherin and Ki67 expression in patients with or without adjuvant therap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8T09:00:45Z</dcterms:created>
  <dc:creator>s.kashiwagi</dc:creator>
  <dc:description/>
  <dc:language>en-US</dc:language>
  <cp:lastModifiedBy>Yashiro</cp:lastModifiedBy>
  <cp:lastPrinted>2010-08-12T06:15:14Z</cp:lastPrinted>
  <dcterms:modified xsi:type="dcterms:W3CDTF">2011-11-26T14:56:24Z</dcterms:modified>
  <cp:revision>195</cp:revision>
  <dc:subject/>
  <dc:title>スライド 1</dc:title>
</cp:coreProperties>
</file>